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3670C-8212-4DBC-948F-77F83CC9F7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51F0F-0EF3-4488-9635-EE24555943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85E0C-2A42-490C-B360-BCDCAFA864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9772E-4865-4A4E-8E24-82C5008568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8812B-E2CE-4B7D-B4C0-5751DACF8C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325D7D-DBE4-49F7-B6F2-3C9C77F668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C16E6-9624-409F-B963-E269FC6526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40F4C-5DC4-4141-BDEE-EEB46D8142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E8006-C681-4C5E-93C1-8CC5061286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2B0E7-F5A0-446E-877A-E093559A8D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72611-83F8-4911-9AC0-556478F883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03C58-94D7-4548-B45E-7C84E5CE58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AE6577-767B-47F5-83C5-ACE3587B75D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57200" y="838080"/>
          <a:ext cx="5257800" cy="2286000"/>
        </p:xfrm>
        <a:graphic>
          <a:graphicData uri="http://schemas.openxmlformats.org/drawingml/2006/table">
            <a:tbl>
              <a:tblPr/>
              <a:tblGrid>
                <a:gridCol w="2664000"/>
                <a:gridCol w="2593800"/>
              </a:tblGrid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 Prim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Vmac239 Gag (1st round  - Outer Forwar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GAAAGTGAAACACACTGAGGAAG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Vmac239 Gag (1st round  - Outer Revers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TCATCCAATTCTTTACTGCTGCAT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Vmac239 Gag (2nd round  - Inner Forwar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ACAGATAGTGCAGAGACACCTAGTGG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Vmac239 Gag (2nd round  - Inner Revers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-CTGTCTACATAGCTCTGAAATGGCTC-3’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1 Env (1st round  - Outer Forwar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TAACCCCACTCTGTGTTA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1 Env (1st round  - Outer Revers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CAGTAGAAAAATTCCCCTC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1 Env (2nd round  - Inner Forwar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ACAGTACAATGTACACATGG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V-1 Env (2nd round  - Inner Revers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'-AATTTCTGGGTCCCCTCCTG-3'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5"/>
          <p:cNvSpPr/>
          <p:nvPr/>
        </p:nvSpPr>
        <p:spPr>
          <a:xfrm>
            <a:off x="380880" y="533520"/>
            <a:ext cx="441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imers used for detection of SHIV-SF162p3 Gag and Env by Nested P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152280" y="15228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8:11Z</dcterms:modified>
  <cp:revision>3972</cp:revision>
  <dc:subject/>
  <dc:title>Slide 1</dc:title>
</cp:coreProperties>
</file>